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9F920D-75DE-4EAC-A636-38624818FA2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2B7D05-EE5E-40A6-A003-7329CF4080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F8B5C2-AE26-4F19-B8FB-AA7DBC2EC86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822A49-C75E-47F4-AF1E-D1A43797EB0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F0398D-2F4B-4FCE-8E9B-8B42F2B11D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D6E9EE-AE71-49D1-A1CB-417492486B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C94E65-70F7-4979-B2A7-B0C1C4F3D0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277C00-D5AD-4EBE-9200-B624B1BED2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B9F984-DB2F-44D5-BFB1-8C2A53DF69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BC0EF3-E0F2-4AFF-B92C-71317FC7FF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EA4754-FDF3-40CA-8AF0-8E3B1AB455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D9D630-1F62-45BC-A767-9B06C366E6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B02A5EB-9F4C-46A5-8431-CE2BED016ACD}" type="slidenum"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직사각형 3"/>
          <p:cNvSpPr/>
          <p:nvPr/>
        </p:nvSpPr>
        <p:spPr>
          <a:xfrm>
            <a:off x="142920" y="214200"/>
            <a:ext cx="8429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able S1. 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2201760" y="2190600"/>
          <a:ext cx="4746600" cy="1812960"/>
        </p:xfrm>
        <a:graphic>
          <a:graphicData uri="http://schemas.openxmlformats.org/drawingml/2006/table">
            <a:tbl>
              <a:tblPr/>
              <a:tblGrid>
                <a:gridCol w="641520"/>
                <a:gridCol w="720720"/>
                <a:gridCol w="792000"/>
                <a:gridCol w="863640"/>
                <a:gridCol w="865080"/>
                <a:gridCol w="863640"/>
              </a:tblGrid>
              <a:tr h="191160">
                <a:tc rowSpan="2"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gridSpan="5"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맑은 고딕"/>
                        </a:rPr>
                        <a:t>Artificial blood of G6PD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73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nalyzer1</a:t>
                      </a:r>
                      <a:r>
                        <a:rPr b="0" lang="ko-KR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nalyzer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nalyzer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nalyzer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nalyzer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116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116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116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116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a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.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.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116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6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0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0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1160">
                <a:tc rowSpan="2"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%CV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.5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.9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.6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.5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.0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11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5"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.5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  <p:sp>
        <p:nvSpPr>
          <p:cNvPr id="43" name="직사각형 5"/>
          <p:cNvSpPr/>
          <p:nvPr/>
        </p:nvSpPr>
        <p:spPr>
          <a:xfrm>
            <a:off x="1403280" y="1782720"/>
            <a:ext cx="6624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Performance of quality control reagent (Artificial blood of G6PD) provided by CareStart™ Biosensor 1 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4" name="직사각형 6"/>
          <p:cNvSpPr/>
          <p:nvPr/>
        </p:nvSpPr>
        <p:spPr>
          <a:xfrm>
            <a:off x="1258920" y="4110120"/>
            <a:ext cx="65530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Acceptance criteria of quality control reagent : All test results of artificial blood of G6PD are within the range 10~30 U/dL and coefficient variant are under 25%, CV = coefficient of variation; G6PD = glucose-6-phosphate dehydrogenase; SD = standard deviation. 3 replicates were run for each condition on 5 CareStart™ Biosensor analyzers.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afterEffect" fill="hold" presetClass="entr" presetID="12" presetSubtype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slide(fromTop)" transition="in">
                                      <p:cBhvr additive="repl">
                                        <p:cTn id="7" dur="500"/>
                                        <p:tgtEl>
                                          <p:spTgt spid="4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8-01T06:20:53Z</dcterms:created>
  <dc:creator>Kyung Tae Noh</dc:creator>
  <dc:description/>
  <dc:language>en-US</dc:language>
  <cp:lastModifiedBy>CS0221</cp:lastModifiedBy>
  <dcterms:modified xsi:type="dcterms:W3CDTF">2020-08-26T08:54:42Z</dcterms:modified>
  <cp:revision>4</cp:revision>
  <dc:subject/>
  <dc:title>슬라이드 1</dc:title>
</cp:coreProperties>
</file>